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3440" y="-7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8E1410-98A6-4D17-8ECE-9C0329128277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A3CEE3-BA58-43DE-91EE-261B7953805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5158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A3CEE3-BA58-43DE-91EE-261B79538055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169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124D1E-77F3-4263-9AFA-F25595A08E0B}" type="datetimeFigureOut">
              <a:rPr lang="ko-KR" altLang="en-US" smtClean="0"/>
              <a:pPr/>
              <a:t>14. 9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A8044C-0E11-4A38-A80E-67878984D7F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05246" y="1115616"/>
            <a:ext cx="5948090" cy="6428643"/>
            <a:chOff x="332656" y="323528"/>
            <a:chExt cx="5948090" cy="6428643"/>
          </a:xfrm>
        </p:grpSpPr>
        <p:pic>
          <p:nvPicPr>
            <p:cNvPr id="94" name="Picture 10" descr="Macintosh HD:Users:bahnlab:Desktop:스크린샷 2014-02-07 오전 9.58.36.png"/>
            <p:cNvPicPr/>
            <p:nvPr/>
          </p:nvPicPr>
          <p:blipFill rotWithShape="1">
            <a:blip r:embed="rId3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096" t="19129" r="23647" b="40435"/>
            <a:stretch/>
          </p:blipFill>
          <p:spPr bwMode="auto">
            <a:xfrm>
              <a:off x="692696" y="725658"/>
              <a:ext cx="2303586" cy="17057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5" name="Picture 7" descr="Macintosh HD:Users:bahnlab:Desktop:스크린샷 2014-02-07 오전 9.52.16.png"/>
            <p:cNvPicPr/>
            <p:nvPr/>
          </p:nvPicPr>
          <p:blipFill rotWithShape="1">
            <a:blip r:embed="rId4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12" t="15802" r="22030" b="39989"/>
            <a:stretch/>
          </p:blipFill>
          <p:spPr bwMode="auto">
            <a:xfrm>
              <a:off x="692696" y="1332410"/>
              <a:ext cx="2303586" cy="19239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6" name="TextBox 95"/>
            <p:cNvSpPr txBox="1"/>
            <p:nvPr/>
          </p:nvSpPr>
          <p:spPr>
            <a:xfrm>
              <a:off x="1585821" y="467544"/>
              <a:ext cx="5470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M16</a:t>
              </a:r>
              <a:endParaRPr lang="ko-KR" altLang="en-US" sz="800" b="1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595748" y="922918"/>
              <a:ext cx="5607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5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8" name="직선 연결선 97"/>
            <p:cNvCxnSpPr/>
            <p:nvPr/>
          </p:nvCxnSpPr>
          <p:spPr>
            <a:xfrm>
              <a:off x="1222402" y="1542634"/>
              <a:ext cx="1233611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9" name="TextBox 98"/>
            <p:cNvSpPr txBox="1"/>
            <p:nvPr/>
          </p:nvSpPr>
          <p:spPr>
            <a:xfrm>
              <a:off x="1668555" y="1546238"/>
              <a:ext cx="5607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5</a:t>
              </a:r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0" name="직선 연결선 99"/>
            <p:cNvCxnSpPr/>
            <p:nvPr/>
          </p:nvCxnSpPr>
          <p:spPr>
            <a:xfrm>
              <a:off x="1178233" y="916726"/>
              <a:ext cx="1121465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직선 연결선 100"/>
            <p:cNvCxnSpPr/>
            <p:nvPr/>
          </p:nvCxnSpPr>
          <p:spPr>
            <a:xfrm>
              <a:off x="863644" y="1541050"/>
              <a:ext cx="392513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TextBox 101"/>
            <p:cNvSpPr txBox="1"/>
            <p:nvPr/>
          </p:nvSpPr>
          <p:spPr>
            <a:xfrm>
              <a:off x="903534" y="1543882"/>
              <a:ext cx="5607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2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1484784" y="1115616"/>
              <a:ext cx="8024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altLang="ko-KR" sz="800" b="1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b="1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M16</a:t>
              </a:r>
              <a:endParaRPr lang="ko-KR" altLang="en-US" sz="800" b="1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0" name="직선 연결선 33"/>
            <p:cNvCxnSpPr/>
            <p:nvPr/>
          </p:nvCxnSpPr>
          <p:spPr>
            <a:xfrm>
              <a:off x="879259" y="1355090"/>
              <a:ext cx="0" cy="981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직선 연결선 31"/>
            <p:cNvCxnSpPr/>
            <p:nvPr/>
          </p:nvCxnSpPr>
          <p:spPr>
            <a:xfrm>
              <a:off x="1246697" y="1348898"/>
              <a:ext cx="0" cy="560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직선 연결선 105"/>
            <p:cNvCxnSpPr/>
            <p:nvPr/>
          </p:nvCxnSpPr>
          <p:spPr>
            <a:xfrm>
              <a:off x="1172642" y="729387"/>
              <a:ext cx="0" cy="981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직선 연결선 29"/>
            <p:cNvCxnSpPr/>
            <p:nvPr/>
          </p:nvCxnSpPr>
          <p:spPr>
            <a:xfrm>
              <a:off x="2281498" y="729387"/>
              <a:ext cx="0" cy="560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직선 연결선 27"/>
            <p:cNvCxnSpPr/>
            <p:nvPr/>
          </p:nvCxnSpPr>
          <p:spPr>
            <a:xfrm>
              <a:off x="2449736" y="1346609"/>
              <a:ext cx="0" cy="560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직사각형 109"/>
            <p:cNvSpPr/>
            <p:nvPr/>
          </p:nvSpPr>
          <p:spPr>
            <a:xfrm>
              <a:off x="701260" y="838513"/>
              <a:ext cx="93582" cy="1110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직사각형 110"/>
            <p:cNvSpPr/>
            <p:nvPr/>
          </p:nvSpPr>
          <p:spPr>
            <a:xfrm>
              <a:off x="964355" y="837701"/>
              <a:ext cx="93582" cy="1110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직사각형 111"/>
            <p:cNvSpPr/>
            <p:nvPr/>
          </p:nvSpPr>
          <p:spPr>
            <a:xfrm>
              <a:off x="2638001" y="837701"/>
              <a:ext cx="358281" cy="1110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직사각형 112"/>
            <p:cNvSpPr/>
            <p:nvPr/>
          </p:nvSpPr>
          <p:spPr>
            <a:xfrm>
              <a:off x="757514" y="1457534"/>
              <a:ext cx="93582" cy="1110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직사각형 113"/>
            <p:cNvSpPr/>
            <p:nvPr/>
          </p:nvSpPr>
          <p:spPr>
            <a:xfrm>
              <a:off x="2265049" y="1678971"/>
              <a:ext cx="358281" cy="1110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140" name="Picture 8" descr="Macintosh HD:Users:bahnlab:Desktop:스크린샷 2014-02-07 오전 9.59.28.png"/>
            <p:cNvPicPr/>
            <p:nvPr/>
          </p:nvPicPr>
          <p:blipFill rotWithShape="1">
            <a:blip r:embed="rId5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44" t="22662" r="21787" b="39985"/>
            <a:stretch/>
          </p:blipFill>
          <p:spPr bwMode="auto">
            <a:xfrm>
              <a:off x="3454307" y="736756"/>
              <a:ext cx="2247507" cy="162559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141" name="직선 연결선 140"/>
            <p:cNvCxnSpPr/>
            <p:nvPr/>
          </p:nvCxnSpPr>
          <p:spPr>
            <a:xfrm>
              <a:off x="4131589" y="930335"/>
              <a:ext cx="1401831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" name="직선 연결선 141"/>
            <p:cNvCxnSpPr/>
            <p:nvPr/>
          </p:nvCxnSpPr>
          <p:spPr>
            <a:xfrm>
              <a:off x="3938232" y="929635"/>
              <a:ext cx="224293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2" name="직선 연결선 171"/>
            <p:cNvCxnSpPr/>
            <p:nvPr/>
          </p:nvCxnSpPr>
          <p:spPr>
            <a:xfrm>
              <a:off x="3956556" y="721457"/>
              <a:ext cx="0" cy="981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직선 연결선 169"/>
            <p:cNvCxnSpPr/>
            <p:nvPr/>
          </p:nvCxnSpPr>
          <p:spPr>
            <a:xfrm>
              <a:off x="4137179" y="721457"/>
              <a:ext cx="0" cy="560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직선 연결선 167"/>
            <p:cNvCxnSpPr/>
            <p:nvPr/>
          </p:nvCxnSpPr>
          <p:spPr>
            <a:xfrm>
              <a:off x="5527246" y="721457"/>
              <a:ext cx="0" cy="981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Box 145"/>
            <p:cNvSpPr txBox="1"/>
            <p:nvPr/>
          </p:nvSpPr>
          <p:spPr>
            <a:xfrm>
              <a:off x="3867516" y="931962"/>
              <a:ext cx="5607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1.4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4689994" y="940611"/>
              <a:ext cx="5607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6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4355906" y="467544"/>
              <a:ext cx="5852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NOP14</a:t>
              </a:r>
              <a:endParaRPr lang="ko-KR" altLang="en-US" sz="800" b="1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149" name="Picture 9" descr="Macintosh HD:Users:bahnlab:Desktop:스크린샷 2014-02-07 오전 10.00.30.png"/>
            <p:cNvPicPr/>
            <p:nvPr/>
          </p:nvPicPr>
          <p:blipFill rotWithShape="1">
            <a:blip r:embed="rId6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57" t="24116" r="15673" b="45073"/>
            <a:stretch/>
          </p:blipFill>
          <p:spPr bwMode="auto">
            <a:xfrm>
              <a:off x="3446251" y="1361931"/>
              <a:ext cx="2445759" cy="140183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150" name="직선 연결선 149"/>
            <p:cNvCxnSpPr/>
            <p:nvPr/>
          </p:nvCxnSpPr>
          <p:spPr>
            <a:xfrm>
              <a:off x="3675792" y="1558050"/>
              <a:ext cx="700915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" name="직선 연결선 150"/>
            <p:cNvCxnSpPr/>
            <p:nvPr/>
          </p:nvCxnSpPr>
          <p:spPr>
            <a:xfrm>
              <a:off x="4343804" y="1558050"/>
              <a:ext cx="1401831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6" name="직선 연결선 62"/>
            <p:cNvCxnSpPr/>
            <p:nvPr/>
          </p:nvCxnSpPr>
          <p:spPr>
            <a:xfrm>
              <a:off x="3695338" y="1330596"/>
              <a:ext cx="0" cy="981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직선 연결선 60"/>
            <p:cNvCxnSpPr/>
            <p:nvPr/>
          </p:nvCxnSpPr>
          <p:spPr>
            <a:xfrm>
              <a:off x="4361847" y="1330596"/>
              <a:ext cx="0" cy="560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직선 연결선 161"/>
            <p:cNvCxnSpPr/>
            <p:nvPr/>
          </p:nvCxnSpPr>
          <p:spPr>
            <a:xfrm>
              <a:off x="5738817" y="1330596"/>
              <a:ext cx="0" cy="981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51"/>
            <p:cNvSpPr txBox="1"/>
            <p:nvPr/>
          </p:nvSpPr>
          <p:spPr>
            <a:xfrm>
              <a:off x="3863576" y="1563895"/>
              <a:ext cx="5607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3.6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TextBox 52"/>
            <p:cNvSpPr txBox="1"/>
            <p:nvPr/>
          </p:nvSpPr>
          <p:spPr>
            <a:xfrm>
              <a:off x="4891783" y="1563895"/>
              <a:ext cx="5607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6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TextBox 53"/>
            <p:cNvSpPr txBox="1"/>
            <p:nvPr/>
          </p:nvSpPr>
          <p:spPr>
            <a:xfrm>
              <a:off x="4417211" y="1115616"/>
              <a:ext cx="8786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altLang="ko-KR" sz="800" b="1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b="1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NOP14</a:t>
              </a:r>
              <a:endParaRPr lang="ko-KR" altLang="en-US" sz="800" b="1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직사각형 157"/>
            <p:cNvSpPr/>
            <p:nvPr/>
          </p:nvSpPr>
          <p:spPr>
            <a:xfrm>
              <a:off x="3467559" y="839433"/>
              <a:ext cx="358281" cy="1110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직사각형 158"/>
            <p:cNvSpPr/>
            <p:nvPr/>
          </p:nvSpPr>
          <p:spPr>
            <a:xfrm>
              <a:off x="5215676" y="841386"/>
              <a:ext cx="453810" cy="3560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직사각형 159"/>
            <p:cNvSpPr/>
            <p:nvPr/>
          </p:nvSpPr>
          <p:spPr>
            <a:xfrm>
              <a:off x="3447623" y="1452869"/>
              <a:ext cx="93582" cy="1110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직사각형 160"/>
            <p:cNvSpPr/>
            <p:nvPr/>
          </p:nvSpPr>
          <p:spPr>
            <a:xfrm>
              <a:off x="5290544" y="1452869"/>
              <a:ext cx="601466" cy="3560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6" name="그룹 70"/>
            <p:cNvGrpSpPr/>
            <p:nvPr/>
          </p:nvGrpSpPr>
          <p:grpSpPr>
            <a:xfrm>
              <a:off x="908720" y="1995100"/>
              <a:ext cx="992988" cy="1424772"/>
              <a:chOff x="487892" y="1512466"/>
              <a:chExt cx="1275032" cy="1571636"/>
            </a:xfrm>
          </p:grpSpPr>
          <p:pic>
            <p:nvPicPr>
              <p:cNvPr id="138" name="Picture 2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grayscl/>
              </a:blip>
              <a:srcRect l="3453" r="81421"/>
              <a:stretch/>
            </p:blipFill>
            <p:spPr bwMode="auto">
              <a:xfrm>
                <a:off x="487892" y="1512466"/>
                <a:ext cx="485658" cy="1571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39" name="Picture 2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grayscl/>
              </a:blip>
              <a:srcRect l="42954" r="31970"/>
              <a:stretch/>
            </p:blipFill>
            <p:spPr bwMode="auto">
              <a:xfrm>
                <a:off x="957818" y="1512466"/>
                <a:ext cx="805106" cy="1571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grpSp>
          <p:nvGrpSpPr>
            <p:cNvPr id="117" name="그룹 73"/>
            <p:cNvGrpSpPr/>
            <p:nvPr/>
          </p:nvGrpSpPr>
          <p:grpSpPr>
            <a:xfrm>
              <a:off x="3789040" y="1985991"/>
              <a:ext cx="1004400" cy="1425600"/>
              <a:chOff x="3888188" y="1619672"/>
              <a:chExt cx="1133388" cy="1571636"/>
            </a:xfrm>
          </p:grpSpPr>
          <p:pic>
            <p:nvPicPr>
              <p:cNvPr id="136" name="Picture 2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grayscl/>
              </a:blip>
              <a:srcRect l="7307" r="78507"/>
              <a:stretch/>
            </p:blipFill>
            <p:spPr bwMode="auto">
              <a:xfrm>
                <a:off x="3888188" y="1619672"/>
                <a:ext cx="372456" cy="1571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37" name="Picture 2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grayscl/>
              </a:blip>
              <a:srcRect l="50000" r="20974"/>
              <a:stretch/>
            </p:blipFill>
            <p:spPr bwMode="auto">
              <a:xfrm>
                <a:off x="4259545" y="1619672"/>
                <a:ext cx="762031" cy="1571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18" name="TextBox 117"/>
            <p:cNvSpPr txBox="1"/>
            <p:nvPr/>
          </p:nvSpPr>
          <p:spPr>
            <a:xfrm>
              <a:off x="1950376" y="2374392"/>
              <a:ext cx="12140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5 kb (WT, 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M16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ko-KR" altLang="en-US" sz="8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9" name="직선 연결선 118"/>
            <p:cNvCxnSpPr/>
            <p:nvPr/>
          </p:nvCxnSpPr>
          <p:spPr>
            <a:xfrm>
              <a:off x="1949387" y="2474973"/>
              <a:ext cx="5607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/>
            <p:cNvSpPr txBox="1"/>
            <p:nvPr/>
          </p:nvSpPr>
          <p:spPr>
            <a:xfrm>
              <a:off x="958405" y="1748414"/>
              <a:ext cx="6222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WT</a:t>
              </a:r>
              <a:endParaRPr lang="ko-KR" altLang="en-US" sz="8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245619" y="1729780"/>
              <a:ext cx="8740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M16</a:t>
              </a:r>
              <a:endParaRPr lang="ko-KR" altLang="en-US" sz="8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2" name="직선 연결선 121"/>
            <p:cNvCxnSpPr/>
            <p:nvPr/>
          </p:nvCxnSpPr>
          <p:spPr>
            <a:xfrm>
              <a:off x="1301276" y="1932087"/>
              <a:ext cx="6168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22"/>
            <p:cNvSpPr txBox="1"/>
            <p:nvPr/>
          </p:nvSpPr>
          <p:spPr>
            <a:xfrm>
              <a:off x="1956568" y="2827969"/>
              <a:ext cx="9917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2 kb (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M16</a:t>
              </a:r>
              <a:r>
                <a:rPr lang="en-US" altLang="ko-KR" sz="8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ko-KR" altLang="en-US" sz="800" i="1" dirty="0" smtClean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4" name="직선 연결선 123"/>
            <p:cNvCxnSpPr/>
            <p:nvPr/>
          </p:nvCxnSpPr>
          <p:spPr>
            <a:xfrm>
              <a:off x="1955579" y="2938685"/>
              <a:ext cx="5607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/>
            <p:cNvSpPr txBox="1"/>
            <p:nvPr/>
          </p:nvSpPr>
          <p:spPr>
            <a:xfrm>
              <a:off x="2086675" y="539552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Kpn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3795806" y="1740790"/>
              <a:ext cx="6222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WT</a:t>
              </a:r>
              <a:endParaRPr lang="ko-KR" altLang="en-US" sz="8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4079054" y="1738718"/>
              <a:ext cx="7592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NOP14</a:t>
              </a:r>
              <a:endParaRPr lang="ko-KR" altLang="en-US" sz="8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3781089" y="539552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Stu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831211" y="2213256"/>
              <a:ext cx="12620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6 kb (WT,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NOP1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ko-KR" altLang="en-US" sz="8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1" name="직선 연결선 130"/>
            <p:cNvCxnSpPr/>
            <p:nvPr/>
          </p:nvCxnSpPr>
          <p:spPr>
            <a:xfrm>
              <a:off x="4830221" y="2321200"/>
              <a:ext cx="5607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131"/>
            <p:cNvSpPr txBox="1"/>
            <p:nvPr/>
          </p:nvSpPr>
          <p:spPr>
            <a:xfrm>
              <a:off x="4829121" y="2418238"/>
              <a:ext cx="11201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3.6 kb (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NOP1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ko-KR" altLang="en-US" sz="800" i="1" dirty="0" smtClean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3" name="직선 연결선 132"/>
            <p:cNvCxnSpPr/>
            <p:nvPr/>
          </p:nvCxnSpPr>
          <p:spPr>
            <a:xfrm>
              <a:off x="4828132" y="2528955"/>
              <a:ext cx="5607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/>
            <p:cNvSpPr txBox="1"/>
            <p:nvPr/>
          </p:nvSpPr>
          <p:spPr>
            <a:xfrm>
              <a:off x="4839491" y="3045554"/>
              <a:ext cx="7060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1.4 kb (WT)</a:t>
              </a:r>
              <a:endParaRPr lang="ko-KR" altLang="en-US" sz="8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5" name="직선 연결선 134"/>
            <p:cNvCxnSpPr/>
            <p:nvPr/>
          </p:nvCxnSpPr>
          <p:spPr>
            <a:xfrm>
              <a:off x="4838502" y="3156100"/>
              <a:ext cx="5607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TextBox 181"/>
            <p:cNvSpPr txBox="1"/>
            <p:nvPr/>
          </p:nvSpPr>
          <p:spPr>
            <a:xfrm>
              <a:off x="972777" y="539552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Kpn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3964860" y="539552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Stu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5359288" y="539552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Stu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692696" y="1178696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Kpn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1070612" y="1178696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Kpn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2270895" y="1178629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Kpn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3541693" y="1178193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Stu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4206657" y="1177082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Stu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5576967" y="1178193"/>
              <a:ext cx="6222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Stu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251" name="Picture 4" descr="Macintosh HD:Users:bahnlab:Desktop:스크린샷 2014-02-07 오전 10.03.15.png"/>
            <p:cNvPicPr/>
            <p:nvPr/>
          </p:nvPicPr>
          <p:blipFill rotWithShape="1">
            <a:blip r:embed="rId9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79" t="19048" r="12306" b="42317"/>
            <a:stretch/>
          </p:blipFill>
          <p:spPr bwMode="auto">
            <a:xfrm>
              <a:off x="781856" y="3931268"/>
              <a:ext cx="2164601" cy="162135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252" name="직선 연결선 251"/>
            <p:cNvCxnSpPr/>
            <p:nvPr/>
          </p:nvCxnSpPr>
          <p:spPr>
            <a:xfrm>
              <a:off x="1096875" y="4117668"/>
              <a:ext cx="615500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3" name="TextBox 252"/>
            <p:cNvSpPr txBox="1"/>
            <p:nvPr/>
          </p:nvSpPr>
          <p:spPr>
            <a:xfrm>
              <a:off x="1221163" y="4123501"/>
              <a:ext cx="5596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3.2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8" name="직선 연결선 277"/>
            <p:cNvCxnSpPr/>
            <p:nvPr/>
          </p:nvCxnSpPr>
          <p:spPr>
            <a:xfrm>
              <a:off x="1109918" y="3923928"/>
              <a:ext cx="0" cy="979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직선 연결선 275"/>
            <p:cNvCxnSpPr/>
            <p:nvPr/>
          </p:nvCxnSpPr>
          <p:spPr>
            <a:xfrm>
              <a:off x="1706013" y="3923928"/>
              <a:ext cx="0" cy="5595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6" name="TextBox 255"/>
            <p:cNvSpPr txBox="1"/>
            <p:nvPr/>
          </p:nvSpPr>
          <p:spPr>
            <a:xfrm>
              <a:off x="1687726" y="3635896"/>
              <a:ext cx="8051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MGE1</a:t>
              </a:r>
              <a:endParaRPr lang="ko-KR" altLang="en-US" sz="800" b="1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257" name="Picture 9" descr="Macintosh HD:Users:bahnlab:Desktop:스크린샷 2014-02-07 오전 10.04.38.png"/>
            <p:cNvPicPr/>
            <p:nvPr/>
          </p:nvPicPr>
          <p:blipFill rotWithShape="1">
            <a:blip r:embed="rId10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92" t="25000" r="23579" b="45067"/>
            <a:stretch/>
          </p:blipFill>
          <p:spPr bwMode="auto">
            <a:xfrm>
              <a:off x="786175" y="4680917"/>
              <a:ext cx="2269304" cy="139886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258" name="직선 연결선 257"/>
            <p:cNvCxnSpPr/>
            <p:nvPr/>
          </p:nvCxnSpPr>
          <p:spPr>
            <a:xfrm>
              <a:off x="986198" y="4854957"/>
              <a:ext cx="1119092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9" name="직선 연결선 258"/>
            <p:cNvCxnSpPr/>
            <p:nvPr/>
          </p:nvCxnSpPr>
          <p:spPr>
            <a:xfrm>
              <a:off x="2091835" y="4854957"/>
              <a:ext cx="195841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0" name="TextBox 259"/>
            <p:cNvSpPr txBox="1"/>
            <p:nvPr/>
          </p:nvSpPr>
          <p:spPr>
            <a:xfrm>
              <a:off x="1375428" y="4860789"/>
              <a:ext cx="5596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4.2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TextBox 260"/>
            <p:cNvSpPr txBox="1"/>
            <p:nvPr/>
          </p:nvSpPr>
          <p:spPr>
            <a:xfrm>
              <a:off x="2005453" y="4860789"/>
              <a:ext cx="5596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1.3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4" name="직선 연결선 273"/>
            <p:cNvCxnSpPr/>
            <p:nvPr/>
          </p:nvCxnSpPr>
          <p:spPr>
            <a:xfrm>
              <a:off x="997059" y="4644008"/>
              <a:ext cx="0" cy="979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직선 연결선 271"/>
            <p:cNvCxnSpPr/>
            <p:nvPr/>
          </p:nvCxnSpPr>
          <p:spPr>
            <a:xfrm>
              <a:off x="2097989" y="4652794"/>
              <a:ext cx="0" cy="5595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직선 연결선 269"/>
            <p:cNvCxnSpPr/>
            <p:nvPr/>
          </p:nvCxnSpPr>
          <p:spPr>
            <a:xfrm>
              <a:off x="2271450" y="4652794"/>
              <a:ext cx="0" cy="5595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5" name="TextBox 264"/>
            <p:cNvSpPr txBox="1"/>
            <p:nvPr/>
          </p:nvSpPr>
          <p:spPr>
            <a:xfrm>
              <a:off x="1526022" y="4347031"/>
              <a:ext cx="8228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altLang="ko-KR" sz="800" b="1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b="1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MGE1</a:t>
              </a:r>
              <a:endParaRPr lang="ko-KR" altLang="en-US" sz="800" b="1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직사각형 265"/>
            <p:cNvSpPr/>
            <p:nvPr/>
          </p:nvSpPr>
          <p:spPr>
            <a:xfrm>
              <a:off x="764704" y="4041005"/>
              <a:ext cx="693001" cy="35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직사각형 266"/>
            <p:cNvSpPr/>
            <p:nvPr/>
          </p:nvSpPr>
          <p:spPr>
            <a:xfrm>
              <a:off x="1894180" y="4041005"/>
              <a:ext cx="871742" cy="35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직사각형 267"/>
            <p:cNvSpPr/>
            <p:nvPr/>
          </p:nvSpPr>
          <p:spPr>
            <a:xfrm rot="10800000" flipV="1">
              <a:off x="909905" y="4771671"/>
              <a:ext cx="652166" cy="35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4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직사각형 268"/>
            <p:cNvSpPr/>
            <p:nvPr/>
          </p:nvSpPr>
          <p:spPr>
            <a:xfrm rot="10800000" flipV="1">
              <a:off x="2462173" y="4771670"/>
              <a:ext cx="652166" cy="35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4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194" name="Picture 3"/>
            <p:cNvPicPr preferRelativeResize="0">
              <a:picLocks noChangeArrowheads="1"/>
            </p:cNvPicPr>
            <p:nvPr/>
          </p:nvPicPr>
          <p:blipFill rotWithShape="1">
            <a:blip r:embed="rId11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637" t="23837" r="43375" b="65044"/>
            <a:stretch/>
          </p:blipFill>
          <p:spPr bwMode="auto">
            <a:xfrm>
              <a:off x="971203" y="5326571"/>
              <a:ext cx="1004400" cy="1425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5" name="TextBox 194"/>
            <p:cNvSpPr txBox="1"/>
            <p:nvPr/>
          </p:nvSpPr>
          <p:spPr>
            <a:xfrm>
              <a:off x="994623" y="5068477"/>
              <a:ext cx="6209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WT</a:t>
              </a:r>
              <a:endParaRPr lang="ko-KR" altLang="en-US" sz="8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1321196" y="5061426"/>
              <a:ext cx="8255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MGE1</a:t>
              </a:r>
              <a:endParaRPr lang="ko-KR" altLang="en-US" sz="8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927770" y="3746004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oR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2059347" y="4114474"/>
              <a:ext cx="5596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5.5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0" name="직선 연결선 199"/>
            <p:cNvCxnSpPr/>
            <p:nvPr/>
          </p:nvCxnSpPr>
          <p:spPr>
            <a:xfrm>
              <a:off x="1684272" y="4116558"/>
              <a:ext cx="1119092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1" name="직선 연결선 200"/>
            <p:cNvCxnSpPr/>
            <p:nvPr/>
          </p:nvCxnSpPr>
          <p:spPr>
            <a:xfrm>
              <a:off x="2786837" y="3923928"/>
              <a:ext cx="0" cy="9792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TextBox 202"/>
            <p:cNvSpPr txBox="1"/>
            <p:nvPr/>
          </p:nvSpPr>
          <p:spPr>
            <a:xfrm>
              <a:off x="2018926" y="5712880"/>
              <a:ext cx="9380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5.5 kb (WT)</a:t>
              </a:r>
              <a:endParaRPr lang="ko-KR" altLang="en-US" sz="8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4" name="직선 연결선 203"/>
            <p:cNvCxnSpPr/>
            <p:nvPr/>
          </p:nvCxnSpPr>
          <p:spPr>
            <a:xfrm>
              <a:off x="2008767" y="5821334"/>
              <a:ext cx="559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TextBox 204"/>
            <p:cNvSpPr txBox="1"/>
            <p:nvPr/>
          </p:nvSpPr>
          <p:spPr>
            <a:xfrm>
              <a:off x="2025293" y="5848162"/>
              <a:ext cx="1015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4.2 kb (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MGE1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ko-KR" altLang="en-US" sz="800" i="1" dirty="0" smtClean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6" name="직선 연결선 205"/>
            <p:cNvCxnSpPr/>
            <p:nvPr/>
          </p:nvCxnSpPr>
          <p:spPr>
            <a:xfrm>
              <a:off x="2008767" y="5964102"/>
              <a:ext cx="559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TextBox 206"/>
            <p:cNvSpPr txBox="1"/>
            <p:nvPr/>
          </p:nvSpPr>
          <p:spPr>
            <a:xfrm>
              <a:off x="2025293" y="5973914"/>
              <a:ext cx="1015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3.2 kb (WT)</a:t>
              </a:r>
              <a:endParaRPr lang="ko-KR" altLang="en-US" sz="800" i="1" dirty="0" smtClean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8" name="직선 연결선 207"/>
            <p:cNvCxnSpPr/>
            <p:nvPr/>
          </p:nvCxnSpPr>
          <p:spPr>
            <a:xfrm>
              <a:off x="2008767" y="6082539"/>
              <a:ext cx="559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9" name="TextBox 208"/>
            <p:cNvSpPr txBox="1"/>
            <p:nvPr/>
          </p:nvSpPr>
          <p:spPr>
            <a:xfrm>
              <a:off x="2016842" y="6285484"/>
              <a:ext cx="10841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1.3 kb (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MGE1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ko-KR" altLang="en-US" sz="800" i="1" dirty="0" smtClean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0" name="직선 연결선 209"/>
            <p:cNvCxnSpPr/>
            <p:nvPr/>
          </p:nvCxnSpPr>
          <p:spPr>
            <a:xfrm>
              <a:off x="2008767" y="6401424"/>
              <a:ext cx="559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1" name="Picture 8" descr="Macintosh HD:Users:bahnlab:Desktop:스크린샷 2014-02-07 오전 10.13.03.png"/>
            <p:cNvPicPr/>
            <p:nvPr/>
          </p:nvPicPr>
          <p:blipFill rotWithShape="1">
            <a:blip r:embed="rId12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26" t="19181" r="11735" b="40409"/>
            <a:stretch/>
          </p:blipFill>
          <p:spPr bwMode="auto">
            <a:xfrm>
              <a:off x="3797400" y="3916613"/>
              <a:ext cx="1626489" cy="193845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212" name="직선 연결선 211"/>
            <p:cNvCxnSpPr/>
            <p:nvPr/>
          </p:nvCxnSpPr>
          <p:spPr>
            <a:xfrm>
              <a:off x="4318899" y="4117668"/>
              <a:ext cx="615500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3" name="TextBox 212"/>
            <p:cNvSpPr txBox="1"/>
            <p:nvPr/>
          </p:nvSpPr>
          <p:spPr>
            <a:xfrm>
              <a:off x="4460883" y="4119149"/>
              <a:ext cx="5596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3.1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9" name="직선 연결선 248"/>
            <p:cNvCxnSpPr/>
            <p:nvPr/>
          </p:nvCxnSpPr>
          <p:spPr>
            <a:xfrm>
              <a:off x="4332292" y="3920500"/>
              <a:ext cx="0" cy="979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5" name="TextBox 214"/>
            <p:cNvSpPr txBox="1"/>
            <p:nvPr/>
          </p:nvSpPr>
          <p:spPr>
            <a:xfrm>
              <a:off x="4438035" y="3635896"/>
              <a:ext cx="5719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HSP10</a:t>
              </a:r>
              <a:endParaRPr lang="ko-KR" altLang="en-US" sz="800" b="1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7" name="직선 연결선 246"/>
            <p:cNvCxnSpPr/>
            <p:nvPr/>
          </p:nvCxnSpPr>
          <p:spPr>
            <a:xfrm>
              <a:off x="4928975" y="3920500"/>
              <a:ext cx="0" cy="979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7" name="Picture 11" descr="Macintosh HD:Users:bahnlab:Desktop:스크린샷 2014-02-07 오전 10.15.19.png"/>
            <p:cNvPicPr/>
            <p:nvPr/>
          </p:nvPicPr>
          <p:blipFill rotWithShape="1">
            <a:blip r:embed="rId13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8" t="19929" r="9971" b="42877"/>
            <a:stretch/>
          </p:blipFill>
          <p:spPr bwMode="auto">
            <a:xfrm>
              <a:off x="3517596" y="4636693"/>
              <a:ext cx="2311070" cy="195841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218" name="직선 연결선 217"/>
            <p:cNvCxnSpPr/>
            <p:nvPr/>
          </p:nvCxnSpPr>
          <p:spPr>
            <a:xfrm>
              <a:off x="4126019" y="4853340"/>
              <a:ext cx="699432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9" name="TextBox 218"/>
            <p:cNvSpPr txBox="1"/>
            <p:nvPr/>
          </p:nvSpPr>
          <p:spPr>
            <a:xfrm>
              <a:off x="4309552" y="4859172"/>
              <a:ext cx="5596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3.1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0" name="직선 연결선 219"/>
            <p:cNvCxnSpPr/>
            <p:nvPr/>
          </p:nvCxnSpPr>
          <p:spPr>
            <a:xfrm>
              <a:off x="4814178" y="4851451"/>
              <a:ext cx="391682" cy="0"/>
            </a:xfrm>
            <a:prstGeom prst="line">
              <a:avLst/>
            </a:prstGeom>
            <a:ln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1" name="TextBox 220"/>
            <p:cNvSpPr txBox="1"/>
            <p:nvPr/>
          </p:nvSpPr>
          <p:spPr>
            <a:xfrm>
              <a:off x="4814750" y="4859172"/>
              <a:ext cx="5596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2.2 kb</a:t>
              </a:r>
              <a:endParaRPr lang="ko-KR" altLang="en-US" sz="7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5" name="직선 연결선 244"/>
            <p:cNvCxnSpPr/>
            <p:nvPr/>
          </p:nvCxnSpPr>
          <p:spPr>
            <a:xfrm>
              <a:off x="4146209" y="4639445"/>
              <a:ext cx="0" cy="979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직선 연결선 242"/>
            <p:cNvCxnSpPr/>
            <p:nvPr/>
          </p:nvCxnSpPr>
          <p:spPr>
            <a:xfrm>
              <a:off x="5183713" y="4639445"/>
              <a:ext cx="0" cy="979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직선 연결선 240"/>
            <p:cNvCxnSpPr/>
            <p:nvPr/>
          </p:nvCxnSpPr>
          <p:spPr>
            <a:xfrm>
              <a:off x="4816452" y="4637459"/>
              <a:ext cx="0" cy="5595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TextBox 224"/>
            <p:cNvSpPr txBox="1"/>
            <p:nvPr/>
          </p:nvSpPr>
          <p:spPr>
            <a:xfrm>
              <a:off x="4348746" y="4347031"/>
              <a:ext cx="9524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altLang="ko-KR" sz="800" b="1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b="1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HSP10</a:t>
              </a:r>
              <a:endParaRPr lang="ko-KR" altLang="en-US" sz="800" b="1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직사각형 225"/>
            <p:cNvSpPr/>
            <p:nvPr/>
          </p:nvSpPr>
          <p:spPr>
            <a:xfrm rot="10800000" flipV="1">
              <a:off x="3785868" y="4039397"/>
              <a:ext cx="652166" cy="35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직사각형 226"/>
            <p:cNvSpPr/>
            <p:nvPr/>
          </p:nvSpPr>
          <p:spPr>
            <a:xfrm rot="10800000" flipV="1">
              <a:off x="4759104" y="4037225"/>
              <a:ext cx="652166" cy="35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직사각형 227"/>
            <p:cNvSpPr/>
            <p:nvPr/>
          </p:nvSpPr>
          <p:spPr>
            <a:xfrm rot="10800000" flipV="1">
              <a:off x="3516506" y="4768627"/>
              <a:ext cx="652166" cy="35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직사각형 228"/>
            <p:cNvSpPr/>
            <p:nvPr/>
          </p:nvSpPr>
          <p:spPr>
            <a:xfrm rot="10800000" flipV="1">
              <a:off x="5116220" y="4768953"/>
              <a:ext cx="712446" cy="35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70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0" name="그룹 179"/>
            <p:cNvGrpSpPr/>
            <p:nvPr/>
          </p:nvGrpSpPr>
          <p:grpSpPr>
            <a:xfrm>
              <a:off x="3861049" y="5326571"/>
              <a:ext cx="998575" cy="1425600"/>
              <a:chOff x="4095376" y="4644008"/>
              <a:chExt cx="912480" cy="1823463"/>
            </a:xfrm>
          </p:grpSpPr>
          <p:pic>
            <p:nvPicPr>
              <p:cNvPr id="239" name="Picture 2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546" t="42135" r="52599" b="47267"/>
              <a:stretch/>
            </p:blipFill>
            <p:spPr bwMode="auto">
              <a:xfrm>
                <a:off x="4095376" y="4644008"/>
                <a:ext cx="316531" cy="18234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40" name="Picture 2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924" t="42135" r="49453" b="47290"/>
              <a:stretch/>
            </p:blipFill>
            <p:spPr bwMode="auto">
              <a:xfrm>
                <a:off x="4406587" y="4644008"/>
                <a:ext cx="601269" cy="18234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231" name="TextBox 230"/>
            <p:cNvSpPr txBox="1"/>
            <p:nvPr/>
          </p:nvSpPr>
          <p:spPr>
            <a:xfrm>
              <a:off x="3861049" y="5080212"/>
              <a:ext cx="6209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WT</a:t>
              </a:r>
              <a:endParaRPr lang="ko-KR" altLang="en-US" sz="8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TextBox 231"/>
            <p:cNvSpPr txBox="1"/>
            <p:nvPr/>
          </p:nvSpPr>
          <p:spPr>
            <a:xfrm>
              <a:off x="4143971" y="5068741"/>
              <a:ext cx="762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HSP10</a:t>
              </a:r>
              <a:endParaRPr lang="ko-KR" altLang="en-US" sz="8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TextBox 233"/>
            <p:cNvSpPr txBox="1"/>
            <p:nvPr/>
          </p:nvSpPr>
          <p:spPr>
            <a:xfrm>
              <a:off x="4154279" y="3744479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BglI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TextBox 234"/>
            <p:cNvSpPr txBox="1"/>
            <p:nvPr/>
          </p:nvSpPr>
          <p:spPr>
            <a:xfrm>
              <a:off x="4877016" y="5747199"/>
              <a:ext cx="13964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3.1 kb (WT, 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HSP10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ko-KR" altLang="en-US" sz="800" i="1" dirty="0" smtClean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6" name="직선 연결선 235"/>
            <p:cNvCxnSpPr/>
            <p:nvPr/>
          </p:nvCxnSpPr>
          <p:spPr>
            <a:xfrm>
              <a:off x="4881485" y="5856238"/>
              <a:ext cx="559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7" name="TextBox 236"/>
            <p:cNvSpPr txBox="1"/>
            <p:nvPr/>
          </p:nvSpPr>
          <p:spPr>
            <a:xfrm>
              <a:off x="4882245" y="5905069"/>
              <a:ext cx="1398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2.2 kb (P</a:t>
              </a:r>
              <a:r>
                <a:rPr lang="en-US" altLang="ko-KR" sz="800" i="1" baseline="-250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CTR4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:</a:t>
              </a:r>
              <a:r>
                <a:rPr lang="en-US" altLang="ko-KR" sz="800" i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HSP10</a:t>
              </a:r>
              <a:r>
                <a:rPr lang="en-US" altLang="ko-KR" sz="800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ko-KR" altLang="en-US" sz="800" i="1" dirty="0" smtClean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8" name="직선 연결선 237"/>
            <p:cNvCxnSpPr/>
            <p:nvPr/>
          </p:nvCxnSpPr>
          <p:spPr>
            <a:xfrm>
              <a:off x="4886716" y="6017740"/>
              <a:ext cx="559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0" name="TextBox 279"/>
            <p:cNvSpPr txBox="1"/>
            <p:nvPr/>
          </p:nvSpPr>
          <p:spPr>
            <a:xfrm>
              <a:off x="1509167" y="3741812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oR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TextBox 280"/>
            <p:cNvSpPr txBox="1"/>
            <p:nvPr/>
          </p:nvSpPr>
          <p:spPr>
            <a:xfrm>
              <a:off x="2601573" y="3741812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oR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TextBox 281"/>
            <p:cNvSpPr txBox="1"/>
            <p:nvPr/>
          </p:nvSpPr>
          <p:spPr>
            <a:xfrm>
              <a:off x="791848" y="4473213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oR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TextBox 282"/>
            <p:cNvSpPr txBox="1"/>
            <p:nvPr/>
          </p:nvSpPr>
          <p:spPr>
            <a:xfrm>
              <a:off x="1859776" y="4478047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oR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2120530" y="4478047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EcoR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TextBox 284"/>
            <p:cNvSpPr txBox="1"/>
            <p:nvPr/>
          </p:nvSpPr>
          <p:spPr>
            <a:xfrm>
              <a:off x="4752288" y="3743337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BglI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TextBox 285"/>
            <p:cNvSpPr txBox="1"/>
            <p:nvPr/>
          </p:nvSpPr>
          <p:spPr>
            <a:xfrm>
              <a:off x="3959058" y="4472071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BglI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TextBox 286"/>
            <p:cNvSpPr txBox="1"/>
            <p:nvPr/>
          </p:nvSpPr>
          <p:spPr>
            <a:xfrm>
              <a:off x="4625018" y="4478047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BglI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5005861" y="4478047"/>
              <a:ext cx="6209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 err="1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BglII</a:t>
              </a:r>
              <a:endParaRPr lang="ko-KR" altLang="en-US" sz="700" i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2" name="직선 연결선 151"/>
            <p:cNvCxnSpPr/>
            <p:nvPr/>
          </p:nvCxnSpPr>
          <p:spPr>
            <a:xfrm>
              <a:off x="4134223" y="1932087"/>
              <a:ext cx="6168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직선 연결선 152"/>
            <p:cNvCxnSpPr/>
            <p:nvPr/>
          </p:nvCxnSpPr>
          <p:spPr>
            <a:xfrm>
              <a:off x="1363759" y="5273030"/>
              <a:ext cx="6168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직선 연결선 153"/>
            <p:cNvCxnSpPr/>
            <p:nvPr/>
          </p:nvCxnSpPr>
          <p:spPr>
            <a:xfrm>
              <a:off x="4199329" y="5273030"/>
              <a:ext cx="6168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/>
            <p:cNvSpPr txBox="1"/>
            <p:nvPr/>
          </p:nvSpPr>
          <p:spPr>
            <a:xfrm>
              <a:off x="404664" y="323528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Calibri"/>
                  <a:cs typeface="Calibri"/>
                </a:rPr>
                <a:t>A</a:t>
              </a:r>
              <a:endParaRPr lang="en-US" b="1" dirty="0">
                <a:latin typeface="Calibri"/>
                <a:cs typeface="Calibri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3212976" y="323528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Calibri"/>
                  <a:cs typeface="Calibri"/>
                </a:rPr>
                <a:t>B</a:t>
              </a:r>
              <a:endParaRPr lang="en-US" b="1" dirty="0">
                <a:latin typeface="Calibri"/>
                <a:cs typeface="Calibri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332656" y="3491880"/>
              <a:ext cx="3068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Calibri"/>
                  <a:cs typeface="Calibri"/>
                </a:rPr>
                <a:t>C</a:t>
              </a:r>
              <a:endParaRPr lang="en-US" b="1" dirty="0">
                <a:latin typeface="Calibri"/>
                <a:cs typeface="Calibri"/>
              </a:endParaRP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3140968" y="3491880"/>
              <a:ext cx="3301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Calibri"/>
                  <a:cs typeface="Calibri"/>
                </a:rPr>
                <a:t>D</a:t>
              </a:r>
              <a:endParaRPr lang="en-US" b="1" dirty="0">
                <a:latin typeface="Calibri"/>
                <a:cs typeface="Calibri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304086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9</TotalTime>
  <Words>164</Words>
  <Application>Microsoft Macintosh PowerPoint</Application>
  <PresentationFormat>On-screen Show (4:3)</PresentationFormat>
  <Paragraphs>6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효짱</dc:creator>
  <cp:lastModifiedBy>Yong-Sun Bahn</cp:lastModifiedBy>
  <cp:revision>32</cp:revision>
  <dcterms:created xsi:type="dcterms:W3CDTF">2014-02-06T16:12:45Z</dcterms:created>
  <dcterms:modified xsi:type="dcterms:W3CDTF">2014-09-16T16:34:10Z</dcterms:modified>
</cp:coreProperties>
</file>